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53"/>
    <p:restoredTop sz="98188" autoAdjust="0"/>
  </p:normalViewPr>
  <p:slideViewPr>
    <p:cSldViewPr snapToGrid="0" snapToObjects="1">
      <p:cViewPr>
        <p:scale>
          <a:sx n="50" d="100"/>
          <a:sy n="50" d="100"/>
        </p:scale>
        <p:origin x="2388" y="1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E028F2-E0D5-A742-A488-C7ACD16AE68E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C141B7-3D2E-FE4C-8C11-DE89D02F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948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558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978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86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001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07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313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376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49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137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425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5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485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8933427"/>
              </p:ext>
            </p:extLst>
          </p:nvPr>
        </p:nvGraphicFramePr>
        <p:xfrm>
          <a:off x="940344" y="719607"/>
          <a:ext cx="4825050" cy="6565671"/>
        </p:xfrm>
        <a:graphic>
          <a:graphicData uri="http://schemas.openxmlformats.org/drawingml/2006/table">
            <a:tbl>
              <a:tblPr/>
              <a:tblGrid>
                <a:gridCol w="8041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844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041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0417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0417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tein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ptide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MAS 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YFPETHI 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B7.2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1-116C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53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MPEAAPPV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5.951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PC1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PAAAPF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13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DFP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PCGAPSV 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66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STD1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PSSAPT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66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BHS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DPKKAPS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7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PA3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DPPPAPP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7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G2A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DPSQAPP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7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PA1P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DPVLAPA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7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RBP1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PVRAPA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5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PCE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GPIAAPQ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54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HANK1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LPPTAPG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.55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HX6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LPYTAPP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.55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GS11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PPPGAPD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54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BP49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QPAMAPG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5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NX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SPPAAPA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54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IP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TPLSAPC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66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BR3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VPETAPE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95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P3B1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VPKIAPD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86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SN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VPMIAPR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86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+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31265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SPG2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YPIRAPRV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12372" marR="12372" marT="9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12372" marR="12372" marT="123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73100" y="7273347"/>
            <a:ext cx="5511800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200" dirty="0">
                <a:latin typeface="Calibri"/>
                <a:cs typeface="Calibri"/>
              </a:rPr>
              <a:t>Human proteins containing peptides derived from alanine and glycine replacement of individual amino acids containing the T1-116C consensus of RXPXXAPXV. Their </a:t>
            </a:r>
            <a:r>
              <a:rPr lang="en-GB" sz="1200" i="1" dirty="0">
                <a:latin typeface="Calibri"/>
                <a:cs typeface="Calibri"/>
              </a:rPr>
              <a:t>in silico</a:t>
            </a:r>
            <a:r>
              <a:rPr lang="en-GB" sz="1200" dirty="0">
                <a:latin typeface="Calibri"/>
                <a:cs typeface="Calibri"/>
              </a:rPr>
              <a:t> predicted HLA-A*0201 binding scores as defined by BIMAS and SYFPETHI, and their experimentally determined HLA-A2 binding (BB7.2 staining) and T1-116C binding.</a:t>
            </a:r>
            <a:endParaRPr lang="en-US" sz="1200" dirty="0">
              <a:latin typeface="Calibri"/>
              <a:cs typeface="Calibri"/>
            </a:endParaRPr>
          </a:p>
          <a:p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317477" y="218258"/>
            <a:ext cx="6540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Calibri"/>
                <a:cs typeface="Calibri"/>
              </a:rPr>
              <a:t>S1 Table. </a:t>
            </a:r>
            <a:r>
              <a:rPr lang="en-GB" sz="1200" b="1" dirty="0">
                <a:latin typeface="Calibri"/>
                <a:cs typeface="Calibri"/>
              </a:rPr>
              <a:t>Predicted peptide HLA-A*0201 binding scores using BIMAS and SYFPETHI, and experimental validation using BB7.2 and T1-116C staining.</a:t>
            </a:r>
            <a:endParaRPr lang="en-US" sz="1200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24176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8</TotalTime>
  <Words>201</Words>
  <Application>Microsoft Office PowerPoint</Application>
  <PresentationFormat>A4 Paper (210x297 mm)</PresentationFormat>
  <Paragraphs>1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 fits into the story after Fig.4. but before Table 1</dc:title>
  <dc:creator>Katica Trenevska</dc:creator>
  <cp:lastModifiedBy>chn off32</cp:lastModifiedBy>
  <cp:revision>35</cp:revision>
  <dcterms:created xsi:type="dcterms:W3CDTF">2018-04-20T07:10:06Z</dcterms:created>
  <dcterms:modified xsi:type="dcterms:W3CDTF">2021-04-01T09:47:41Z</dcterms:modified>
</cp:coreProperties>
</file>